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>
        <p:scale>
          <a:sx n="150" d="100"/>
          <a:sy n="150" d="100"/>
        </p:scale>
        <p:origin x="-72" y="55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F11AC-F3C3-4DD5-85B7-93E1159D8BAD}" type="datetimeFigureOut">
              <a:rPr lang="en-CA" smtClean="0"/>
              <a:pPr/>
              <a:t>14/08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872401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F11AC-F3C3-4DD5-85B7-93E1159D8BAD}" type="datetimeFigureOut">
              <a:rPr lang="en-CA" smtClean="0"/>
              <a:pPr/>
              <a:t>14/08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666328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F11AC-F3C3-4DD5-85B7-93E1159D8BAD}" type="datetimeFigureOut">
              <a:rPr lang="en-CA" smtClean="0"/>
              <a:pPr/>
              <a:t>14/08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274320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F11AC-F3C3-4DD5-85B7-93E1159D8BAD}" type="datetimeFigureOut">
              <a:rPr lang="en-CA" smtClean="0"/>
              <a:pPr/>
              <a:t>14/08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452652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F11AC-F3C3-4DD5-85B7-93E1159D8BAD}" type="datetimeFigureOut">
              <a:rPr lang="en-CA" smtClean="0"/>
              <a:pPr/>
              <a:t>14/08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85660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F11AC-F3C3-4DD5-85B7-93E1159D8BAD}" type="datetimeFigureOut">
              <a:rPr lang="en-CA" smtClean="0"/>
              <a:pPr/>
              <a:t>14/08/20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226397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F11AC-F3C3-4DD5-85B7-93E1159D8BAD}" type="datetimeFigureOut">
              <a:rPr lang="en-CA" smtClean="0"/>
              <a:pPr/>
              <a:t>14/08/2013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447378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F11AC-F3C3-4DD5-85B7-93E1159D8BAD}" type="datetimeFigureOut">
              <a:rPr lang="en-CA" smtClean="0"/>
              <a:pPr/>
              <a:t>14/08/2013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533177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F11AC-F3C3-4DD5-85B7-93E1159D8BAD}" type="datetimeFigureOut">
              <a:rPr lang="en-CA" smtClean="0"/>
              <a:pPr/>
              <a:t>14/08/2013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744582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F11AC-F3C3-4DD5-85B7-93E1159D8BAD}" type="datetimeFigureOut">
              <a:rPr lang="en-CA" smtClean="0"/>
              <a:pPr/>
              <a:t>14/08/20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637379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F11AC-F3C3-4DD5-85B7-93E1159D8BAD}" type="datetimeFigureOut">
              <a:rPr lang="en-CA" smtClean="0"/>
              <a:pPr/>
              <a:t>14/08/20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077729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7F11AC-F3C3-4DD5-85B7-93E1159D8BAD}" type="datetimeFigureOut">
              <a:rPr lang="en-CA" smtClean="0"/>
              <a:pPr/>
              <a:t>14/08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381278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541107" y="6588224"/>
            <a:ext cx="5962972" cy="24929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CA" sz="1200" b="1" dirty="0">
                <a:latin typeface="Times New Roman" pitchFamily="18" charset="0"/>
                <a:cs typeface="Times New Roman" pitchFamily="18" charset="0"/>
              </a:rPr>
              <a:t>Supplemental</a:t>
            </a:r>
            <a:r>
              <a:rPr lang="en-CA" sz="1200" b="1" dirty="0" smtClean="0">
                <a:latin typeface="Times New Roman" pitchFamily="18" charset="0"/>
                <a:cs typeface="Times New Roman" pitchFamily="18" charset="0"/>
              </a:rPr>
              <a:t> Fig. S2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Neighbour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-joining</a:t>
            </a:r>
            <a:r>
              <a:rPr lang="en-US" sz="1200" i="1" u="sng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tree of deduced amino acid sequences corresponding to AQPs from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P. </a:t>
            </a:r>
            <a:r>
              <a:rPr lang="en-US" sz="1200" i="1" dirty="0" err="1">
                <a:latin typeface="Times New Roman" pitchFamily="18" charset="0"/>
                <a:cs typeface="Times New Roman" pitchFamily="18" charset="0"/>
              </a:rPr>
              <a:t>contorta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(Pc),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P. </a:t>
            </a:r>
            <a:r>
              <a:rPr lang="en-US" sz="1200" i="1" dirty="0" err="1">
                <a:latin typeface="Times New Roman" pitchFamily="18" charset="0"/>
                <a:cs typeface="Times New Roman" pitchFamily="18" charset="0"/>
              </a:rPr>
              <a:t>banksiana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(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Pb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),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P. </a:t>
            </a:r>
            <a:r>
              <a:rPr lang="en-US" sz="1200" i="1" dirty="0" err="1">
                <a:latin typeface="Times New Roman" pitchFamily="18" charset="0"/>
                <a:cs typeface="Times New Roman" pitchFamily="18" charset="0"/>
              </a:rPr>
              <a:t>trichocarpa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(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Pt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) and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Arabidopsis thaliana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(At). Clusters are designated according to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as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tonoplast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intrinsic protein (TIP),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nodulin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-like intrinsic protein (NIP), plasma membrane intrinsic protein (PIP), and small basic intrinsic protein (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SIP;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Johanso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et al. 2001, Plant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Physiol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126:1358-1369; Almeida-Rodriguez et al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., 2010.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Physiol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Plant 14:321-333.) .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TIPs can be further differentiated into TIP1 and TIP2 sequences, while PIPs can also be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subclassified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as PIP1 and PIP2 sequences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Johanso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et al. 2001)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. The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Arabidopsis thaliana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genome does not appear to contain X-intrinsic protein (XIP)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AQPs (Quigley et al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2001, Genome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Biol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3:research0001.1-0001.17),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and none were detected in the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P. </a:t>
            </a:r>
            <a:r>
              <a:rPr lang="en-US" sz="1200" i="1" dirty="0" err="1">
                <a:latin typeface="Times New Roman" pitchFamily="18" charset="0"/>
                <a:cs typeface="Times New Roman" pitchFamily="18" charset="0"/>
              </a:rPr>
              <a:t>banksiana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or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P. </a:t>
            </a:r>
            <a:r>
              <a:rPr lang="en-US" sz="1200" i="1" dirty="0" err="1">
                <a:latin typeface="Times New Roman" pitchFamily="18" charset="0"/>
                <a:cs typeface="Times New Roman" pitchFamily="18" charset="0"/>
              </a:rPr>
              <a:t>contorta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Sanger sequence data used in this study.  Sequences pointed with arrows were investigated by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qRT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-PCR. The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Neighbour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-joining consensus tree was inferred from 1000 bootstrap replicates. Bootstrap values are shown next to their branches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.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en-CA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4826" y="770978"/>
            <a:ext cx="5354501" cy="5012447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Donut 5"/>
          <p:cNvSpPr/>
          <p:nvPr/>
        </p:nvSpPr>
        <p:spPr>
          <a:xfrm>
            <a:off x="846889" y="535852"/>
            <a:ext cx="5345917" cy="5345865"/>
          </a:xfrm>
          <a:prstGeom prst="donu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CA"/>
          </a:p>
        </p:txBody>
      </p:sp>
      <p:sp>
        <p:nvSpPr>
          <p:cNvPr id="7" name="Text Box 2"/>
          <p:cNvSpPr txBox="1">
            <a:spLocks noChangeArrowheads="1"/>
          </p:cNvSpPr>
          <p:nvPr/>
        </p:nvSpPr>
        <p:spPr bwMode="auto">
          <a:xfrm>
            <a:off x="5645556" y="1145023"/>
            <a:ext cx="471479" cy="248595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200">
                <a:effectLst/>
                <a:latin typeface="Times New Roman"/>
                <a:ea typeface="Calibri"/>
                <a:cs typeface="Times New Roman"/>
              </a:rPr>
              <a:t>PIPs</a:t>
            </a:r>
            <a:endParaRPr lang="en-CA" sz="110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8" name="Straight Arrow Connector 7"/>
          <p:cNvCxnSpPr/>
          <p:nvPr/>
        </p:nvCxnSpPr>
        <p:spPr>
          <a:xfrm flipH="1">
            <a:off x="4811998" y="1454979"/>
            <a:ext cx="191382" cy="181812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/>
          <p:cNvCxnSpPr/>
          <p:nvPr/>
        </p:nvCxnSpPr>
        <p:spPr>
          <a:xfrm flipH="1">
            <a:off x="5463943" y="3090169"/>
            <a:ext cx="287075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/>
          <p:cNvCxnSpPr/>
          <p:nvPr/>
        </p:nvCxnSpPr>
        <p:spPr>
          <a:xfrm flipV="1">
            <a:off x="2653098" y="4949799"/>
            <a:ext cx="85724" cy="258311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/>
          <p:cNvCxnSpPr/>
          <p:nvPr/>
        </p:nvCxnSpPr>
        <p:spPr>
          <a:xfrm flipV="1">
            <a:off x="1253019" y="3592483"/>
            <a:ext cx="257171" cy="42861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 flipH="1" flipV="1">
            <a:off x="4395181" y="4223047"/>
            <a:ext cx="882953" cy="984670"/>
          </a:xfrm>
          <a:prstGeom prst="line">
            <a:avLst/>
          </a:prstGeom>
          <a:ln w="952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 flipH="1" flipV="1">
            <a:off x="900328" y="2651981"/>
            <a:ext cx="1311001" cy="264599"/>
          </a:xfrm>
          <a:prstGeom prst="line">
            <a:avLst/>
          </a:prstGeom>
          <a:ln w="952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 flipH="1" flipV="1">
            <a:off x="1947714" y="1059541"/>
            <a:ext cx="770942" cy="1078966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" name="Text Box 2"/>
          <p:cNvSpPr txBox="1">
            <a:spLocks noChangeArrowheads="1"/>
          </p:cNvSpPr>
          <p:nvPr/>
        </p:nvSpPr>
        <p:spPr bwMode="auto">
          <a:xfrm>
            <a:off x="1370572" y="5419923"/>
            <a:ext cx="471479" cy="248595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200">
                <a:effectLst/>
                <a:latin typeface="Times New Roman"/>
                <a:ea typeface="Calibri"/>
                <a:cs typeface="Times New Roman"/>
              </a:rPr>
              <a:t>TIPs</a:t>
            </a:r>
            <a:endParaRPr lang="en-CA" sz="110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16" name="Text Box 2"/>
          <p:cNvSpPr txBox="1">
            <a:spLocks noChangeArrowheads="1"/>
          </p:cNvSpPr>
          <p:nvPr/>
        </p:nvSpPr>
        <p:spPr bwMode="auto">
          <a:xfrm>
            <a:off x="697262" y="1454954"/>
            <a:ext cx="555757" cy="304699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200" dirty="0">
                <a:effectLst/>
                <a:latin typeface="Times New Roman"/>
                <a:ea typeface="Calibri"/>
                <a:cs typeface="Times New Roman"/>
              </a:rPr>
              <a:t>NIPs</a:t>
            </a:r>
            <a:endParaRPr lang="en-CA" sz="1100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17" name="Straight Connector 16"/>
          <p:cNvCxnSpPr/>
          <p:nvPr/>
        </p:nvCxnSpPr>
        <p:spPr>
          <a:xfrm flipH="1" flipV="1">
            <a:off x="3101978" y="578602"/>
            <a:ext cx="248027" cy="1301844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" name="Text Box 2"/>
          <p:cNvSpPr txBox="1">
            <a:spLocks noChangeArrowheads="1"/>
          </p:cNvSpPr>
          <p:nvPr/>
        </p:nvSpPr>
        <p:spPr bwMode="auto">
          <a:xfrm>
            <a:off x="2001132" y="461039"/>
            <a:ext cx="471479" cy="248595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200">
                <a:effectLst/>
                <a:latin typeface="Times New Roman"/>
                <a:ea typeface="Calibri"/>
                <a:cs typeface="Times New Roman"/>
              </a:rPr>
              <a:t>SIPs</a:t>
            </a:r>
            <a:endParaRPr lang="en-CA" sz="1100">
              <a:effectLst/>
              <a:latin typeface="Calibri"/>
              <a:ea typeface="Calibri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0704699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4</TotalTime>
  <Words>203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shiba</dc:creator>
  <cp:lastModifiedBy>Janice</cp:lastModifiedBy>
  <cp:revision>22</cp:revision>
  <dcterms:created xsi:type="dcterms:W3CDTF">2013-07-09T00:40:26Z</dcterms:created>
  <dcterms:modified xsi:type="dcterms:W3CDTF">2013-08-14T15:08:27Z</dcterms:modified>
</cp:coreProperties>
</file>